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F89992-8642-4377-9E9B-0B7CFBF1A6E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D471C-BC34-4871-B2C5-E26EA35F68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766F7D-E010-4FCB-911F-5D059B8757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A7B20D-61AE-42C1-9491-AA2199F3DB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6BEC74-47D0-4CDC-89BB-318563B743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60576-5342-4C7B-B088-88967F476C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0726E-498F-4E74-B073-3CC260F276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981C20-2F7B-43F8-A331-96A16114A3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6F31A4-F20A-4D5E-9242-B917936F15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6E76AF-5242-4C3E-8E29-2F8162B566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96744-C160-41CD-BC68-8C71181EB8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076165-2435-481D-A4DA-FC1E9AE111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E43411-F2F6-49B4-B949-A6A29C1644E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wmf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9"/>
          <p:cNvSpPr/>
          <p:nvPr/>
        </p:nvSpPr>
        <p:spPr>
          <a:xfrm>
            <a:off x="3700800" y="4605480"/>
            <a:ext cx="1227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1        2       3     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11"/>
          <p:cNvSpPr/>
          <p:nvPr/>
        </p:nvSpPr>
        <p:spPr>
          <a:xfrm>
            <a:off x="1608840" y="18684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3"/>
          <p:cNvSpPr/>
          <p:nvPr/>
        </p:nvSpPr>
        <p:spPr>
          <a:xfrm>
            <a:off x="1608120" y="3094200"/>
            <a:ext cx="281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3799"/>
          <p:cNvGrpSpPr/>
          <p:nvPr/>
        </p:nvGrpSpPr>
        <p:grpSpPr>
          <a:xfrm>
            <a:off x="1967040" y="1890720"/>
            <a:ext cx="2971800" cy="1175040"/>
            <a:chOff x="1967040" y="1890720"/>
            <a:chExt cx="2971800" cy="1175040"/>
          </a:xfrm>
        </p:grpSpPr>
        <p:sp>
          <p:nvSpPr>
            <p:cNvPr id="45" name="CaixaDeTexto 49"/>
            <p:cNvSpPr/>
            <p:nvPr/>
          </p:nvSpPr>
          <p:spPr>
            <a:xfrm>
              <a:off x="2844720" y="1890720"/>
              <a:ext cx="793440" cy="11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y 0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</a:t>
              </a:r>
              <a:r>
                <a:rPr b="0" lang="pt-BR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g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</a:t>
              </a:r>
              <a:r>
                <a:rPr b="0" lang="pt-BR" sz="14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ga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T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6" name="Group 3801"/>
            <p:cNvGrpSpPr/>
            <p:nvPr/>
          </p:nvGrpSpPr>
          <p:grpSpPr>
            <a:xfrm>
              <a:off x="1967040" y="1890720"/>
              <a:ext cx="2971800" cy="1175040"/>
              <a:chOff x="1967040" y="1890720"/>
              <a:chExt cx="2971800" cy="1175040"/>
            </a:xfrm>
          </p:grpSpPr>
          <p:sp>
            <p:nvSpPr>
              <p:cNvPr id="47" name="CaixaDeTexto 49"/>
              <p:cNvSpPr/>
              <p:nvPr/>
            </p:nvSpPr>
            <p:spPr>
              <a:xfrm>
                <a:off x="1967040" y="2119320"/>
                <a:ext cx="589320" cy="946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. 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. 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. 3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Gr. 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CaixaDeTexto 50"/>
              <p:cNvSpPr/>
              <p:nvPr/>
            </p:nvSpPr>
            <p:spPr>
              <a:xfrm>
                <a:off x="3964320" y="1890720"/>
                <a:ext cx="767520" cy="1159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BR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Day 7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on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pt-BR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. cruz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pt-BR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Non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pt-BR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T. cruzi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Retângulo 53"/>
              <p:cNvSpPr/>
              <p:nvPr/>
            </p:nvSpPr>
            <p:spPr>
              <a:xfrm>
                <a:off x="1967040" y="2149200"/>
                <a:ext cx="2971800" cy="22860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Retângulo 54"/>
              <p:cNvSpPr/>
              <p:nvPr/>
            </p:nvSpPr>
            <p:spPr>
              <a:xfrm>
                <a:off x="1967040" y="2384280"/>
                <a:ext cx="2971800" cy="2113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Retângulo 55"/>
              <p:cNvSpPr/>
              <p:nvPr/>
            </p:nvSpPr>
            <p:spPr>
              <a:xfrm>
                <a:off x="1967040" y="2805120"/>
                <a:ext cx="2971800" cy="2095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Retângulo 56"/>
              <p:cNvSpPr/>
              <p:nvPr/>
            </p:nvSpPr>
            <p:spPr>
              <a:xfrm>
                <a:off x="1967040" y="2595600"/>
                <a:ext cx="2971800" cy="2095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3" name="Text Box 14"/>
          <p:cNvSpPr/>
          <p:nvPr/>
        </p:nvSpPr>
        <p:spPr>
          <a:xfrm>
            <a:off x="1677960" y="4952880"/>
            <a:ext cx="293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4" name="Object 39"/>
          <p:cNvGraphicFramePr/>
          <p:nvPr/>
        </p:nvGraphicFramePr>
        <p:xfrm>
          <a:off x="1752480" y="4572000"/>
          <a:ext cx="3429000" cy="3084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5" name="Object 39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52480" y="4572000"/>
                    <a:ext cx="3429000" cy="3084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Text Box 3817"/>
          <p:cNvSpPr/>
          <p:nvPr/>
        </p:nvSpPr>
        <p:spPr>
          <a:xfrm>
            <a:off x="4467600" y="48769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3819"/>
          <p:cNvSpPr/>
          <p:nvPr/>
        </p:nvSpPr>
        <p:spPr>
          <a:xfrm>
            <a:off x="4453200" y="60958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3820"/>
          <p:cNvSpPr/>
          <p:nvPr/>
        </p:nvSpPr>
        <p:spPr>
          <a:xfrm>
            <a:off x="4376880" y="609588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3817"/>
          <p:cNvSpPr/>
          <p:nvPr/>
        </p:nvSpPr>
        <p:spPr>
          <a:xfrm>
            <a:off x="2945160" y="571500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3817"/>
          <p:cNvSpPr/>
          <p:nvPr/>
        </p:nvSpPr>
        <p:spPr>
          <a:xfrm>
            <a:off x="3565800" y="55627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817"/>
          <p:cNvSpPr/>
          <p:nvPr/>
        </p:nvSpPr>
        <p:spPr>
          <a:xfrm>
            <a:off x="4194360" y="518148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3820"/>
          <p:cNvSpPr/>
          <p:nvPr/>
        </p:nvSpPr>
        <p:spPr>
          <a:xfrm>
            <a:off x="4072320" y="624852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3819"/>
          <p:cNvSpPr/>
          <p:nvPr/>
        </p:nvSpPr>
        <p:spPr>
          <a:xfrm>
            <a:off x="3507120" y="61722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3820"/>
          <p:cNvSpPr/>
          <p:nvPr/>
        </p:nvSpPr>
        <p:spPr>
          <a:xfrm>
            <a:off x="3430800" y="61722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Object 33"/>
          <p:cNvGraphicFramePr/>
          <p:nvPr/>
        </p:nvGraphicFramePr>
        <p:xfrm>
          <a:off x="1905120" y="7902720"/>
          <a:ext cx="1020600" cy="10666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6" name="Object 3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905120" y="7902720"/>
                    <a:ext cx="1020600" cy="106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7" name="Object 34"/>
          <p:cNvGraphicFramePr/>
          <p:nvPr/>
        </p:nvGraphicFramePr>
        <p:xfrm>
          <a:off x="2666880" y="7902720"/>
          <a:ext cx="968400" cy="106668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8" name="Object 3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2666880" y="7902720"/>
                    <a:ext cx="968400" cy="106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9" name="Object 35"/>
          <p:cNvGraphicFramePr/>
          <p:nvPr/>
        </p:nvGraphicFramePr>
        <p:xfrm>
          <a:off x="3354480" y="7902720"/>
          <a:ext cx="988920" cy="106668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0" name="Object 35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354480" y="7902720"/>
                    <a:ext cx="988920" cy="1066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Text Box 10"/>
          <p:cNvSpPr/>
          <p:nvPr/>
        </p:nvSpPr>
        <p:spPr>
          <a:xfrm>
            <a:off x="2133360" y="7773840"/>
            <a:ext cx="57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r.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1"/>
          <p:cNvSpPr/>
          <p:nvPr/>
        </p:nvSpPr>
        <p:spPr>
          <a:xfrm>
            <a:off x="2866680" y="7773840"/>
            <a:ext cx="57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r. 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12"/>
          <p:cNvSpPr/>
          <p:nvPr/>
        </p:nvSpPr>
        <p:spPr>
          <a:xfrm>
            <a:off x="3580920" y="7773840"/>
            <a:ext cx="578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Gr. 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4"/>
          <p:cNvSpPr/>
          <p:nvPr/>
        </p:nvSpPr>
        <p:spPr>
          <a:xfrm>
            <a:off x="1981080" y="7674120"/>
            <a:ext cx="3276720" cy="13176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ixaDeTexto 49"/>
          <p:cNvSpPr/>
          <p:nvPr/>
        </p:nvSpPr>
        <p:spPr>
          <a:xfrm>
            <a:off x="1695600" y="7489800"/>
            <a:ext cx="29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6" name="Object 52"/>
          <p:cNvGraphicFramePr/>
          <p:nvPr/>
        </p:nvGraphicFramePr>
        <p:xfrm>
          <a:off x="4038480" y="7848720"/>
          <a:ext cx="1447920" cy="115092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7" name="Object 52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4038480" y="7848720"/>
                    <a:ext cx="1447920" cy="11509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8" name="Object 4"/>
          <p:cNvGraphicFramePr/>
          <p:nvPr/>
        </p:nvGraphicFramePr>
        <p:xfrm>
          <a:off x="3124080" y="2876400"/>
          <a:ext cx="2210040" cy="20034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9" name="Object 4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124080" y="2876400"/>
                    <a:ext cx="2210040" cy="200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0" name="Text Box 3817"/>
          <p:cNvSpPr/>
          <p:nvPr/>
        </p:nvSpPr>
        <p:spPr>
          <a:xfrm>
            <a:off x="4626360" y="3276720"/>
            <a:ext cx="299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3819"/>
          <p:cNvSpPr/>
          <p:nvPr/>
        </p:nvSpPr>
        <p:spPr>
          <a:xfrm>
            <a:off x="4005360" y="38988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3820"/>
          <p:cNvSpPr/>
          <p:nvPr/>
        </p:nvSpPr>
        <p:spPr>
          <a:xfrm>
            <a:off x="4324680" y="3886200"/>
            <a:ext cx="269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4"/>
          <p:cNvSpPr/>
          <p:nvPr/>
        </p:nvSpPr>
        <p:spPr>
          <a:xfrm>
            <a:off x="3352680" y="3581280"/>
            <a:ext cx="152640" cy="838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14"/>
          <p:cNvSpPr/>
          <p:nvPr/>
        </p:nvSpPr>
        <p:spPr>
          <a:xfrm>
            <a:off x="3363480" y="3094200"/>
            <a:ext cx="275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43"/>
          <p:cNvSpPr/>
          <p:nvPr/>
        </p:nvSpPr>
        <p:spPr>
          <a:xfrm rot="16200000">
            <a:off x="2905200" y="3795120"/>
            <a:ext cx="9226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</a:rPr>
              <a:t>H2K</a:t>
            </a:r>
            <a:r>
              <a:rPr b="0" lang="pt-BR" sz="700" spc="-1" strike="noStrike" baseline="30000">
                <a:solidFill>
                  <a:srgbClr val="000000"/>
                </a:solidFill>
                <a:latin typeface="Arial"/>
              </a:rPr>
              <a:t>d</a:t>
            </a:r>
            <a:r>
              <a:rPr b="0" lang="pt-BR" sz="700" spc="-1" strike="noStrike">
                <a:solidFill>
                  <a:srgbClr val="000000"/>
                </a:solidFill>
                <a:latin typeface="Arial"/>
              </a:rPr>
              <a:t>-IYNVGQVSI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BR" sz="700" spc="-1" strike="noStrike">
                <a:solidFill>
                  <a:srgbClr val="000000"/>
                </a:solidFill>
                <a:latin typeface="Arial"/>
              </a:rPr>
              <a:t>CD8</a:t>
            </a:r>
            <a:r>
              <a:rPr b="0" lang="pt-BR" sz="7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pt-BR" sz="700" spc="-1" strike="noStrike">
                <a:solidFill>
                  <a:srgbClr val="000000"/>
                </a:solidFill>
                <a:latin typeface="Arial"/>
              </a:rPr>
              <a:t> cells (%)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1269720" y="3346560"/>
            <a:ext cx="1970280" cy="1560960"/>
            <a:chOff x="1269720" y="3346560"/>
            <a:chExt cx="1970280" cy="1560960"/>
          </a:xfrm>
        </p:grpSpPr>
        <p:sp>
          <p:nvSpPr>
            <p:cNvPr id="87" name="Text Box 42"/>
            <p:cNvSpPr/>
            <p:nvPr/>
          </p:nvSpPr>
          <p:spPr>
            <a:xfrm rot="16200000">
              <a:off x="954720" y="3846960"/>
              <a:ext cx="1201680" cy="215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Parasitemia (X10</a:t>
              </a:r>
              <a:r>
                <a:rPr b="0" lang="en-US" sz="800" spc="-1" strike="noStrike" baseline="30000">
                  <a:solidFill>
                    <a:srgbClr val="000000"/>
                  </a:solidFill>
                  <a:latin typeface="Arial"/>
                </a:rPr>
                <a:t>6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/mL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952640" y="3349800"/>
              <a:ext cx="1243080" cy="1184040"/>
            </a:xfrm>
            <a:prstGeom prst="rect">
              <a:avLst/>
            </a:prstGeom>
            <a:solidFill>
              <a:srgbClr val="ffffff"/>
            </a:solidFill>
            <a:ln w="1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136240" y="4800600"/>
              <a:ext cx="837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Days post inoculat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952640" y="4533840"/>
              <a:ext cx="1243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195264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213048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230832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248616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V="1">
              <a:off x="266220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284004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V="1">
              <a:off x="301788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3195720" y="4533840"/>
              <a:ext cx="0" cy="47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189864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07648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25432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243216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261000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78604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96388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3141720" y="46274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952640" y="3349800"/>
              <a:ext cx="124308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rot="5400000">
              <a:off x="1132560" y="4323240"/>
              <a:ext cx="274680" cy="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 vert="eaVert" rot="10800000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1952640" y="3349440"/>
              <a:ext cx="0" cy="1184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1903320" y="453384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1903320" y="401940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903320" y="350532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1712880" y="448308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820520" y="448452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712880" y="396864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820520" y="396864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1712880" y="3454560"/>
              <a:ext cx="98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1820520" y="3454560"/>
              <a:ext cx="356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3195720" y="3349440"/>
              <a:ext cx="0" cy="1184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2041560" y="3538440"/>
              <a:ext cx="1065240" cy="611280"/>
            </a:xfrm>
            <a:custGeom>
              <a:avLst/>
              <a:gdLst/>
              <a:ahLst/>
              <a:rect l="l" t="t" r="r" b="b"/>
              <a:pathLst>
                <a:path w="2143" h="1289">
                  <a:moveTo>
                    <a:pt x="0" y="0"/>
                  </a:moveTo>
                  <a:lnTo>
                    <a:pt x="536" y="327"/>
                  </a:lnTo>
                  <a:lnTo>
                    <a:pt x="1072" y="655"/>
                  </a:lnTo>
                  <a:lnTo>
                    <a:pt x="1607" y="1141"/>
                  </a:lnTo>
                  <a:lnTo>
                    <a:pt x="2143" y="1289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2041560" y="3878280"/>
              <a:ext cx="1065240" cy="550800"/>
            </a:xfrm>
            <a:custGeom>
              <a:avLst/>
              <a:gdLst/>
              <a:ahLst/>
              <a:rect l="l" t="t" r="r" b="b"/>
              <a:pathLst>
                <a:path w="2143" h="1163">
                  <a:moveTo>
                    <a:pt x="0" y="0"/>
                  </a:moveTo>
                  <a:lnTo>
                    <a:pt x="536" y="433"/>
                  </a:lnTo>
                  <a:lnTo>
                    <a:pt x="1072" y="591"/>
                  </a:lnTo>
                  <a:lnTo>
                    <a:pt x="1607" y="1075"/>
                  </a:lnTo>
                  <a:lnTo>
                    <a:pt x="2143" y="1163"/>
                  </a:lnTo>
                </a:path>
              </a:pathLst>
            </a:custGeom>
            <a:noFill/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2041560" y="4084200"/>
              <a:ext cx="0" cy="65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016000" y="408456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041560" y="4149720"/>
              <a:ext cx="0" cy="92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016000" y="424188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2011320" y="4121280"/>
              <a:ext cx="60480" cy="5688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480" bIns="-6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2308320" y="3944520"/>
              <a:ext cx="0" cy="493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282760" y="394488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308320" y="3994200"/>
              <a:ext cx="0" cy="65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282760" y="405936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2278080" y="3965400"/>
              <a:ext cx="60480" cy="572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2575080" y="3804840"/>
              <a:ext cx="0" cy="33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320" bIns="-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549520" y="380520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2575080" y="3838680"/>
              <a:ext cx="0" cy="42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2549520" y="388152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544840" y="3809880"/>
              <a:ext cx="60120" cy="572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2840040" y="3575160"/>
              <a:ext cx="0" cy="331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2816280" y="357516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2840040" y="3608280"/>
              <a:ext cx="0" cy="399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840" bIns="-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816280" y="364824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2811600" y="3579840"/>
              <a:ext cx="58680" cy="572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3106800" y="3454200"/>
              <a:ext cx="0" cy="83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3081240" y="345456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3106800" y="3538440"/>
              <a:ext cx="0" cy="135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3081240" y="367344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3076560" y="3510000"/>
              <a:ext cx="60480" cy="572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2041560" y="4321080"/>
              <a:ext cx="0" cy="108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2016000" y="432108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2041560" y="4429080"/>
              <a:ext cx="0" cy="104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2016000" y="4403880"/>
              <a:ext cx="52560" cy="507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2308320" y="4119120"/>
              <a:ext cx="0" cy="104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2282760" y="411948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308320" y="4224240"/>
              <a:ext cx="0" cy="204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282760" y="442908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2282760" y="4199040"/>
              <a:ext cx="50760" cy="4896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2575080" y="4064040"/>
              <a:ext cx="0" cy="85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549520" y="406404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2575080" y="4149720"/>
              <a:ext cx="0" cy="1396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549520" y="428940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2548080" y="4124160"/>
              <a:ext cx="52200" cy="493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2840040" y="3854160"/>
              <a:ext cx="0" cy="651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2816280" y="385452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840040" y="3919680"/>
              <a:ext cx="0" cy="95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816280" y="4014720"/>
              <a:ext cx="4932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814480" y="3895560"/>
              <a:ext cx="52560" cy="493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flipV="1">
              <a:off x="3106800" y="3787560"/>
              <a:ext cx="0" cy="903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3081240" y="378792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3106800" y="3878280"/>
              <a:ext cx="0" cy="1555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3081240" y="4033800"/>
              <a:ext cx="507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3081240" y="3852720"/>
              <a:ext cx="52560" cy="511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20" bIns="4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1981080" y="3367080"/>
              <a:ext cx="730440" cy="318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2301480" y="342576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A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421000" y="3416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473920" y="3425760"/>
              <a:ext cx="171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700" spc="-1" strike="noStrike">
                  <a:solidFill>
                    <a:srgbClr val="000000"/>
                  </a:solidFill>
                  <a:latin typeface="Arial"/>
                </a:rPr>
                <a:t>-gal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109960" y="3441600"/>
              <a:ext cx="60120" cy="57240"/>
            </a:xfrm>
            <a:prstGeom prst="ellipse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6120" bIns="-6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2301840" y="3537000"/>
              <a:ext cx="246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BR" sz="700" spc="-1" strike="noStrike">
                  <a:solidFill>
                    <a:srgbClr val="000000"/>
                  </a:solidFill>
                  <a:latin typeface="Arial"/>
                </a:rPr>
                <a:t>AdTS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114640" y="3562200"/>
              <a:ext cx="52200" cy="493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rot="16200000">
              <a:off x="1005480" y="3852360"/>
              <a:ext cx="1149120" cy="137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Parasitemia/mL      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3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9T22:53:37Z</dcterms:created>
  <dc:creator>Mauricio</dc:creator>
  <dc:description/>
  <dc:language>en-US</dc:language>
  <cp:lastModifiedBy>Mauricio</cp:lastModifiedBy>
  <dcterms:modified xsi:type="dcterms:W3CDTF">2012-04-06T00:48:02Z</dcterms:modified>
  <cp:revision>586</cp:revision>
  <dc:subject/>
  <dc:title>Slide 1</dc:title>
</cp:coreProperties>
</file>